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317" r:id="rId2"/>
    <p:sldId id="331" r:id="rId3"/>
    <p:sldId id="333" r:id="rId4"/>
    <p:sldId id="332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E0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260"/>
    <p:restoredTop sz="96336"/>
  </p:normalViewPr>
  <p:slideViewPr>
    <p:cSldViewPr snapToGrid="0" snapToObjects="1" showGuides="1">
      <p:cViewPr varScale="1">
        <p:scale>
          <a:sx n="129" d="100"/>
          <a:sy n="129" d="100"/>
        </p:scale>
        <p:origin x="125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A13E5A-F993-8747-8C2F-A78C56A403B4}" type="datetimeFigureOut">
              <a:rPr lang="en-US" smtClean="0"/>
              <a:t>10/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5CC1D9-4400-1F4C-943C-BE8F3A8588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4730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2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318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2188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418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652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423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1115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92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2423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691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74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041BE-E1EF-4043-B326-A238D518CE1C}" type="datetimeFigureOut">
              <a:rPr lang="en-US" smtClean="0"/>
              <a:t>10/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96B2E-40AE-3840-9C82-5D3F7087F3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499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01FD5A3-15BA-8244-8B95-C6037A237DAF}"/>
              </a:ext>
            </a:extLst>
          </p:cNvPr>
          <p:cNvSpPr txBox="1"/>
          <p:nvPr/>
        </p:nvSpPr>
        <p:spPr>
          <a:xfrm>
            <a:off x="-24492" y="0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0BE5255-0570-9144-91D2-B7BCFD1DB57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665" t="4742" r="15620" b="7088"/>
          <a:stretch/>
        </p:blipFill>
        <p:spPr>
          <a:xfrm>
            <a:off x="89209" y="369332"/>
            <a:ext cx="4928840" cy="86076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4890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0B8E940B-8BF4-644D-AAFA-36A2FBB675DC}"/>
              </a:ext>
            </a:extLst>
          </p:cNvPr>
          <p:cNvSpPr txBox="1"/>
          <p:nvPr/>
        </p:nvSpPr>
        <p:spPr>
          <a:xfrm>
            <a:off x="-24492" y="0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9D7BAC4-2439-2546-BE7F-94D7C2B5CC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39539"/>
            <a:ext cx="6858000" cy="70649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89321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0B8E940B-8BF4-644D-AAFA-36A2FBB675DC}"/>
              </a:ext>
            </a:extLst>
          </p:cNvPr>
          <p:cNvSpPr txBox="1"/>
          <p:nvPr/>
        </p:nvSpPr>
        <p:spPr>
          <a:xfrm>
            <a:off x="-24492" y="0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A26B810-3718-124E-BFC7-CA6D371DCC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764305"/>
            <a:ext cx="6858000" cy="76153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89224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0B8E940B-8BF4-644D-AAFA-36A2FBB675DC}"/>
              </a:ext>
            </a:extLst>
          </p:cNvPr>
          <p:cNvSpPr txBox="1"/>
          <p:nvPr/>
        </p:nvSpPr>
        <p:spPr>
          <a:xfrm>
            <a:off x="-24492" y="0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884C1B3-F59C-1A42-AA97-593ED0917F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0550" y="1530350"/>
            <a:ext cx="5676900" cy="6083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0652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9</TotalTime>
  <Words>12</Words>
  <Application>Microsoft Macintosh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ngan, Cory M.</dc:creator>
  <cp:lastModifiedBy>Dungan, Cory M.</cp:lastModifiedBy>
  <cp:revision>61</cp:revision>
  <dcterms:created xsi:type="dcterms:W3CDTF">2021-03-08T16:18:05Z</dcterms:created>
  <dcterms:modified xsi:type="dcterms:W3CDTF">2021-10-02T22:07:22Z</dcterms:modified>
</cp:coreProperties>
</file>